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846" r:id="rId2"/>
    <p:sldId id="847" r:id="rId3"/>
    <p:sldId id="848" r:id="rId4"/>
    <p:sldId id="849" r:id="rId5"/>
    <p:sldId id="84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EA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92B101F-2573-406E-AB11-1D6A91C99D51}" v="4" dt="2026-02-28T21:10:03.685"/>
  </p1510:revLst>
</p1510:revInfo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Medium Style 2 –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1EBBBCC-DAD2-459C-BE2E-F6DE35CF9A28}" styleName="Dark Style 2 –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86"/>
    <p:restoredTop sz="94694"/>
  </p:normalViewPr>
  <p:slideViewPr>
    <p:cSldViewPr snapToGrid="0">
      <p:cViewPr varScale="1">
        <p:scale>
          <a:sx n="67" d="100"/>
          <a:sy n="67" d="100"/>
        </p:scale>
        <p:origin x="77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O'Neal" userId="56ebcf1a-7abb-4491-bf50-219a1885c9d7" providerId="ADAL" clId="{1BD60534-1C3A-45A6-9228-77E3D2A01395}"/>
    <pc:docChg chg="undo custSel addSld delSld modSld sldOrd">
      <pc:chgData name="David O'Neal" userId="56ebcf1a-7abb-4491-bf50-219a1885c9d7" providerId="ADAL" clId="{1BD60534-1C3A-45A6-9228-77E3D2A01395}" dt="2026-02-28T21:12:44.852" v="611" actId="14734"/>
      <pc:docMkLst>
        <pc:docMk/>
      </pc:docMkLst>
      <pc:sldChg chg="addSp delSp modSp mod ord">
        <pc:chgData name="David O'Neal" userId="56ebcf1a-7abb-4491-bf50-219a1885c9d7" providerId="ADAL" clId="{1BD60534-1C3A-45A6-9228-77E3D2A01395}" dt="2026-02-24T21:47:50.187" v="535" actId="1076"/>
        <pc:sldMkLst>
          <pc:docMk/>
          <pc:sldMk cId="458494746" sldId="844"/>
        </pc:sldMkLst>
        <pc:spChg chg="add mod">
          <ac:chgData name="David O'Neal" userId="56ebcf1a-7abb-4491-bf50-219a1885c9d7" providerId="ADAL" clId="{1BD60534-1C3A-45A6-9228-77E3D2A01395}" dt="2026-02-24T21:47:50.187" v="535" actId="1076"/>
          <ac:spMkLst>
            <pc:docMk/>
            <pc:sldMk cId="458494746" sldId="844"/>
            <ac:spMk id="2" creationId="{F71880C4-F1E3-E838-CD81-DD3CA0F7AFD8}"/>
          </ac:spMkLst>
        </pc:spChg>
      </pc:sldChg>
      <pc:sldChg chg="addSp modSp mod">
        <pc:chgData name="David O'Neal" userId="56ebcf1a-7abb-4491-bf50-219a1885c9d7" providerId="ADAL" clId="{1BD60534-1C3A-45A6-9228-77E3D2A01395}" dt="2026-02-24T09:43:22.705" v="462"/>
        <pc:sldMkLst>
          <pc:docMk/>
          <pc:sldMk cId="672629908" sldId="847"/>
        </pc:sldMkLst>
        <pc:spChg chg="mod">
          <ac:chgData name="David O'Neal" userId="56ebcf1a-7abb-4491-bf50-219a1885c9d7" providerId="ADAL" clId="{1BD60534-1C3A-45A6-9228-77E3D2A01395}" dt="2026-02-24T09:36:07.001" v="456"/>
          <ac:spMkLst>
            <pc:docMk/>
            <pc:sldMk cId="672629908" sldId="847"/>
            <ac:spMk id="3" creationId="{49D6A1EC-86B0-6955-5FDF-82B470812088}"/>
          </ac:spMkLst>
        </pc:spChg>
      </pc:sldChg>
      <pc:sldChg chg="modSp add mod">
        <pc:chgData name="David O'Neal" userId="56ebcf1a-7abb-4491-bf50-219a1885c9d7" providerId="ADAL" clId="{1BD60534-1C3A-45A6-9228-77E3D2A01395}" dt="2026-02-24T21:45:35.185" v="490" actId="207"/>
        <pc:sldMkLst>
          <pc:docMk/>
          <pc:sldMk cId="2171865043" sldId="848"/>
        </pc:sldMkLst>
        <pc:spChg chg="mod">
          <ac:chgData name="David O'Neal" userId="56ebcf1a-7abb-4491-bf50-219a1885c9d7" providerId="ADAL" clId="{1BD60534-1C3A-45A6-9228-77E3D2A01395}" dt="2026-02-24T21:45:35.185" v="490" actId="207"/>
          <ac:spMkLst>
            <pc:docMk/>
            <pc:sldMk cId="2171865043" sldId="848"/>
            <ac:spMk id="5" creationId="{8CE33A12-1AE5-5586-AC14-142C1C1B9EC7}"/>
          </ac:spMkLst>
        </pc:spChg>
      </pc:sldChg>
      <pc:sldChg chg="addSp delSp modSp new mod setBg">
        <pc:chgData name="David O'Neal" userId="56ebcf1a-7abb-4491-bf50-219a1885c9d7" providerId="ADAL" clId="{1BD60534-1C3A-45A6-9228-77E3D2A01395}" dt="2026-02-28T21:12:44.852" v="611" actId="14734"/>
        <pc:sldMkLst>
          <pc:docMk/>
          <pc:sldMk cId="800411204" sldId="849"/>
        </pc:sldMkLst>
        <pc:spChg chg="add mod">
          <ac:chgData name="David O'Neal" userId="56ebcf1a-7abb-4491-bf50-219a1885c9d7" providerId="ADAL" clId="{1BD60534-1C3A-45A6-9228-77E3D2A01395}" dt="2026-02-24T21:46:16.197" v="502" actId="20577"/>
          <ac:spMkLst>
            <pc:docMk/>
            <pc:sldMk cId="800411204" sldId="849"/>
            <ac:spMk id="5" creationId="{5BF78B8E-D48A-7EC6-EC44-969DF8803EA9}"/>
          </ac:spMkLst>
        </pc:spChg>
        <pc:graphicFrameChg chg="add mod modGraphic">
          <ac:chgData name="David O'Neal" userId="56ebcf1a-7abb-4491-bf50-219a1885c9d7" providerId="ADAL" clId="{1BD60534-1C3A-45A6-9228-77E3D2A01395}" dt="2026-02-28T21:12:44.852" v="611" actId="14734"/>
          <ac:graphicFrameMkLst>
            <pc:docMk/>
            <pc:sldMk cId="800411204" sldId="849"/>
            <ac:graphicFrameMk id="4" creationId="{78C74060-996F-C9F2-882D-87233E9276C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DF117C-B59C-0E46-A02F-DF8465525638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C0E4AB-54B3-A348-8ECE-004B74FA2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816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4ACC8A-B6C9-B388-07C0-EC66A71EBE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F7BF66D-2FC0-2915-52B8-C416B1EB749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88E2997-5BA9-F97F-4449-58EA032B312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9F49F1-F216-CE7C-3E1B-5070AE81FFB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12F7267-D563-449A-A98A-1DA37D8997F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68657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CF7FF-7447-7037-00D3-62D3E03927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345E1D-9C80-1B85-8C20-61CDE16064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4F4CE8-71E4-C6E1-464B-3FECDCC52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94ECE1-4F92-DE22-4B5B-154F3781B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12B448-924A-1F36-4F4A-0F3F92E29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173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916E27-46C5-8704-F83A-BAF6C5CF2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F5995A-D907-DF43-DEC0-15B21B87AA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2C606-4F52-F3DD-EE30-D63BB904C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5E6697-A7AB-E01B-FDD6-35684E0A9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5D4AC8-85A7-38B9-16FF-424E0C84C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907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38B862-F3A3-CA4F-3E05-1406F0DEB0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F89BE1-13AE-CAA7-5A5B-1198AD0C4A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7E3F6C-405B-F1FD-4CFC-D08377DA1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A985F-2BBF-D984-B697-F842F13BA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2F1710-0E06-F411-DFB2-A2D1966A9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027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C9DCD-5C5F-388C-6D50-B0B2A3C6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F58A33-B284-4E00-A0E8-729D335496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544C76-E91C-F0B9-47A4-31DAEAA04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82C380-5B34-45BF-1148-F1E1F43AC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77632E-0D04-9218-9A01-FFDD8129B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050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4B0AC2-84F7-EB2F-CD50-5EACE0066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4532EB-79E9-A337-CC18-A74A7B7FE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70E55-BC4F-6E1F-326A-08D8EDA4E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E8DD61-3D93-1019-E70A-0D99136EB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3EFAC7-6E19-0E29-89E1-55CB3ECAA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544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EBCC4-37CE-E16D-1EAD-F0854E1492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AC578-9E8F-1C44-BE21-8A4797D064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034182-F4A0-5C3F-F9D0-BFA2D629D8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BEAC4-4558-B853-FDDA-248C88C5F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C64282-926E-7BB7-CA69-ED3337D94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E3FAC2-EB4A-9506-F56E-1CE289BE2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15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A85D4-F3CA-11AE-7D5A-93C00C1E4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DFAB93-F4DD-9E99-F68A-8297D6B53A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C918BF-0E51-D7D6-A516-1FBB9E81B0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A76213-8553-A829-A904-73B684845D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FA3443-D9C7-ABE2-8831-C11F6DF024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B0F043-73B7-41E4-EBED-957628EB3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95714F-6A28-0A1E-9B5C-AD84C6EA8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7444F4-1CC3-5034-6A90-7C15B4113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6A84A-36E3-91D2-0C81-7FA5EE3FA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EC4379-9DEA-A364-DE67-F872A28E7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093210-4C99-55BC-AEFE-C0EAE1A41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7B95F5-7438-5852-A09E-5C0D64472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85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8AD799-8C76-1B7E-1796-3BADFA1E8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F47A69-0E89-E638-6430-5F913B56C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99B394-29CB-43F7-1F0C-E68B36A72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930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5B6E7-379A-D826-2785-1F0BAAEFD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8D86C6-E1F2-8985-FF1B-E0EACB8F90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19E18B-57D4-5B3D-3986-7FD10B81FC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E29EDB-5F92-7DB6-D1DD-11DA62C40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4791D5-CC5F-817D-2E69-2EB944A1A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93F00F-FF74-37C9-9CF6-914367097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040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1C852-5DBA-C2D4-43C1-D46D24C1C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1477DB-A8EF-60D5-5803-773EBEA2AF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8BB8FF-30C4-557A-2070-ED9036E631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CF549C-9130-3555-11A6-1A78D74B5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283B7-6C76-7E65-2655-A98A99720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D988AD-7EF5-2DEA-C59C-0069232CC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07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FC0CFD-FF46-5D99-D3CD-DF7974B7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A09455-3E0C-7881-6025-23B99B05A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B43A38-180C-6714-7951-C05356422B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DF164E-E107-FC45-8590-9484BDE42101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1B8F5B-D83F-F465-0768-60EDEF8D37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09984B-8445-C954-3FBC-63DFB19F90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DCB92B-3503-0441-9347-B12E4A25C1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762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sv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498379B-DFDA-E043-ABDE-CAF4B1310B1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Appendix</a:t>
            </a:r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6119B5AA-47E0-46A4-9F26-38935961F29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727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23727-9E2B-1E90-1BF7-34F5B0205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dex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D6A1EC-86B0-6955-5FDF-82B4708120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1: Device Failures</a:t>
            </a:r>
          </a:p>
          <a:p>
            <a:r>
              <a:rPr lang="en-US" dirty="0"/>
              <a:t>S2: Device Survival</a:t>
            </a:r>
          </a:p>
          <a:p>
            <a:r>
              <a:rPr lang="en-US" dirty="0"/>
              <a:t>S3: MARD – day by day analysis</a:t>
            </a:r>
          </a:p>
        </p:txBody>
      </p:sp>
    </p:spTree>
    <p:extLst>
      <p:ext uri="{BB962C8B-B14F-4D97-AF65-F5344CB8AC3E}">
        <p14:creationId xmlns:p14="http://schemas.microsoft.com/office/powerpoint/2010/main" val="6726299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B4C3B1-C031-6F6C-96C8-5E18964651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8CE33A12-1AE5-5586-AC14-142C1C1B9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2114" y="319635"/>
            <a:ext cx="4345612" cy="651405"/>
          </a:xfrm>
        </p:spPr>
        <p:txBody>
          <a:bodyPr>
            <a:normAutofit/>
          </a:bodyPr>
          <a:lstStyle/>
          <a:p>
            <a:r>
              <a:rPr lang="en-US" sz="1800" b="1" dirty="0">
                <a:latin typeface="+mn-lt"/>
              </a:rPr>
              <a:t>S1 Device Failur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5A1BD09-258F-5EFE-5663-5EF4627B4F75}"/>
              </a:ext>
            </a:extLst>
          </p:cNvPr>
          <p:cNvSpPr txBox="1"/>
          <p:nvPr/>
        </p:nvSpPr>
        <p:spPr>
          <a:xfrm>
            <a:off x="4945222" y="522663"/>
            <a:ext cx="1953998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Total devices: 38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1D70FB9-8318-647C-0151-1F04A8D17175}"/>
              </a:ext>
            </a:extLst>
          </p:cNvPr>
          <p:cNvCxnSpPr>
            <a:cxnSpLocks/>
          </p:cNvCxnSpPr>
          <p:nvPr/>
        </p:nvCxnSpPr>
        <p:spPr>
          <a:xfrm>
            <a:off x="5543859" y="884476"/>
            <a:ext cx="0" cy="75088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7DB7D06-730F-A8A9-570F-B7C90F24699E}"/>
              </a:ext>
            </a:extLst>
          </p:cNvPr>
          <p:cNvSpPr txBox="1"/>
          <p:nvPr/>
        </p:nvSpPr>
        <p:spPr>
          <a:xfrm>
            <a:off x="6780999" y="1104870"/>
            <a:ext cx="2638944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Pre-insertion failure: 12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B8DA16B-C464-99EF-A4BE-92A5EF5F6FA6}"/>
              </a:ext>
            </a:extLst>
          </p:cNvPr>
          <p:cNvCxnSpPr>
            <a:endCxn id="8" idx="1"/>
          </p:cNvCxnSpPr>
          <p:nvPr/>
        </p:nvCxnSpPr>
        <p:spPr>
          <a:xfrm>
            <a:off x="5543859" y="1279227"/>
            <a:ext cx="1237140" cy="1030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D426A4D-72B7-4207-A7B1-18CAD460F160}"/>
              </a:ext>
            </a:extLst>
          </p:cNvPr>
          <p:cNvSpPr txBox="1"/>
          <p:nvPr/>
        </p:nvSpPr>
        <p:spPr>
          <a:xfrm>
            <a:off x="4939333" y="1682379"/>
            <a:ext cx="2313334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Devices inserted: 26 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0092EE3-4675-0219-C856-6EDAEB9990EF}"/>
              </a:ext>
            </a:extLst>
          </p:cNvPr>
          <p:cNvCxnSpPr>
            <a:cxnSpLocks/>
            <a:stCxn id="12" idx="1"/>
          </p:cNvCxnSpPr>
          <p:nvPr/>
        </p:nvCxnSpPr>
        <p:spPr>
          <a:xfrm flipH="1">
            <a:off x="4315258" y="1867045"/>
            <a:ext cx="62407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FCBE46A-FDC2-094E-56C8-BE40071716FD}"/>
              </a:ext>
            </a:extLst>
          </p:cNvPr>
          <p:cNvCxnSpPr>
            <a:cxnSpLocks/>
          </p:cNvCxnSpPr>
          <p:nvPr/>
        </p:nvCxnSpPr>
        <p:spPr>
          <a:xfrm>
            <a:off x="7252667" y="1846688"/>
            <a:ext cx="106913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07023C2-FDDA-4644-A427-F9047F0F0329}"/>
              </a:ext>
            </a:extLst>
          </p:cNvPr>
          <p:cNvSpPr txBox="1"/>
          <p:nvPr/>
        </p:nvSpPr>
        <p:spPr>
          <a:xfrm>
            <a:off x="2514836" y="1682378"/>
            <a:ext cx="1800422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Pilot phase: 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CC7A3A-E107-CD3C-B06D-7C3F89426BC9}"/>
              </a:ext>
            </a:extLst>
          </p:cNvPr>
          <p:cNvSpPr txBox="1"/>
          <p:nvPr/>
        </p:nvSpPr>
        <p:spPr>
          <a:xfrm>
            <a:off x="8341408" y="1692688"/>
            <a:ext cx="2313334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Main phase: 22 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C83D8882-63E8-317C-2A8C-9FF454B6B1F9}"/>
              </a:ext>
            </a:extLst>
          </p:cNvPr>
          <p:cNvCxnSpPr/>
          <p:nvPr/>
        </p:nvCxnSpPr>
        <p:spPr>
          <a:xfrm>
            <a:off x="8503396" y="2069756"/>
            <a:ext cx="0" cy="8264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F1279B1C-2859-7DA4-76C3-C86AE1F02EE4}"/>
              </a:ext>
            </a:extLst>
          </p:cNvPr>
          <p:cNvSpPr txBox="1"/>
          <p:nvPr/>
        </p:nvSpPr>
        <p:spPr>
          <a:xfrm>
            <a:off x="10098591" y="2885865"/>
            <a:ext cx="1226931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Failures: 8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8B3625C-5598-F3B8-571D-CBB30D71E5B0}"/>
              </a:ext>
            </a:extLst>
          </p:cNvPr>
          <p:cNvCxnSpPr/>
          <p:nvPr/>
        </p:nvCxnSpPr>
        <p:spPr>
          <a:xfrm>
            <a:off x="4125605" y="2069756"/>
            <a:ext cx="0" cy="8264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E9F2694-FA09-9D9E-C263-6E964F19F575}"/>
              </a:ext>
            </a:extLst>
          </p:cNvPr>
          <p:cNvCxnSpPr/>
          <p:nvPr/>
        </p:nvCxnSpPr>
        <p:spPr>
          <a:xfrm>
            <a:off x="2693314" y="2069756"/>
            <a:ext cx="0" cy="8264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70082CE-752F-0B3E-880C-E3F9DC9AE6B8}"/>
              </a:ext>
            </a:extLst>
          </p:cNvPr>
          <p:cNvSpPr txBox="1"/>
          <p:nvPr/>
        </p:nvSpPr>
        <p:spPr>
          <a:xfrm>
            <a:off x="8114050" y="2885865"/>
            <a:ext cx="1800422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Successful: 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390C71E-1BF1-3384-FFFF-9F8DF54AA9C9}"/>
              </a:ext>
            </a:extLst>
          </p:cNvPr>
          <p:cNvSpPr txBox="1"/>
          <p:nvPr/>
        </p:nvSpPr>
        <p:spPr>
          <a:xfrm>
            <a:off x="3876156" y="2903254"/>
            <a:ext cx="1333780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Failures: 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37A1997-6001-E56F-BB5E-D3C20B50A9E2}"/>
              </a:ext>
            </a:extLst>
          </p:cNvPr>
          <p:cNvSpPr txBox="1"/>
          <p:nvPr/>
        </p:nvSpPr>
        <p:spPr>
          <a:xfrm>
            <a:off x="2224032" y="2906485"/>
            <a:ext cx="1529340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Successful: 3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8723927B-F489-5198-D8FB-E9EF48FDA89C}"/>
              </a:ext>
            </a:extLst>
          </p:cNvPr>
          <p:cNvCxnSpPr/>
          <p:nvPr/>
        </p:nvCxnSpPr>
        <p:spPr>
          <a:xfrm>
            <a:off x="10419860" y="2059446"/>
            <a:ext cx="0" cy="82641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1" name="Group 80">
            <a:extLst>
              <a:ext uri="{FF2B5EF4-FFF2-40B4-BE49-F238E27FC236}">
                <a16:creationId xmlns:a16="http://schemas.microsoft.com/office/drawing/2014/main" id="{1A0A98A8-5D4F-8F20-AFCF-712DAE2553D7}"/>
              </a:ext>
            </a:extLst>
          </p:cNvPr>
          <p:cNvGrpSpPr/>
          <p:nvPr/>
        </p:nvGrpSpPr>
        <p:grpSpPr>
          <a:xfrm>
            <a:off x="2988702" y="3655384"/>
            <a:ext cx="2395244" cy="553998"/>
            <a:chOff x="1495692" y="3908129"/>
            <a:chExt cx="2395244" cy="553998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8E67839-7B54-A6C2-5B8E-607E10655D2E}"/>
                </a:ext>
              </a:extLst>
            </p:cNvPr>
            <p:cNvSpPr txBox="1"/>
            <p:nvPr/>
          </p:nvSpPr>
          <p:spPr>
            <a:xfrm>
              <a:off x="1495692" y="3908129"/>
              <a:ext cx="2395244" cy="553998"/>
            </a:xfrm>
            <a:prstGeom prst="rect">
              <a:avLst/>
            </a:prstGeom>
            <a:noFill/>
            <a:ln>
              <a:noFill/>
              <a:prstDash val="dash"/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SIM1    </a:t>
              </a:r>
            </a:p>
            <a:p>
              <a:r>
                <a:rPr lang="en-US" sz="1000" dirty="0"/>
                <a:t>SIM2</a:t>
              </a:r>
            </a:p>
            <a:p>
              <a:r>
                <a:rPr lang="en-US" sz="1000" dirty="0"/>
                <a:t>SIM3</a:t>
              </a:r>
            </a:p>
          </p:txBody>
        </p:sp>
        <p:pic>
          <p:nvPicPr>
            <p:cNvPr id="37" name="Graphic 36" descr="Checkbox Crossed with solid fill">
              <a:extLst>
                <a:ext uri="{FF2B5EF4-FFF2-40B4-BE49-F238E27FC236}">
                  <a16:creationId xmlns:a16="http://schemas.microsoft.com/office/drawing/2014/main" id="{72666ADB-2E6F-1E35-A244-9639047A1B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906901" y="3908129"/>
              <a:ext cx="243874" cy="243874"/>
            </a:xfrm>
            <a:prstGeom prst="rect">
              <a:avLst/>
            </a:prstGeom>
          </p:spPr>
        </p:pic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400B0F7A-192D-EDDA-D345-6DA734AFAD4A}"/>
                </a:ext>
              </a:extLst>
            </p:cNvPr>
            <p:cNvCxnSpPr>
              <a:cxnSpLocks/>
            </p:cNvCxnSpPr>
            <p:nvPr/>
          </p:nvCxnSpPr>
          <p:spPr>
            <a:xfrm>
              <a:off x="2134389" y="4041760"/>
              <a:ext cx="179286" cy="0"/>
            </a:xfrm>
            <a:prstGeom prst="straightConnector1">
              <a:avLst/>
            </a:prstGeom>
            <a:ln>
              <a:noFill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40" name="Graphic 39" descr="Checkmark with solid fill">
              <a:extLst>
                <a:ext uri="{FF2B5EF4-FFF2-40B4-BE49-F238E27FC236}">
                  <a16:creationId xmlns:a16="http://schemas.microsoft.com/office/drawing/2014/main" id="{B9B38E71-DEF0-F26E-0BDB-E926BB8104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967843" y="4288442"/>
              <a:ext cx="121990" cy="121990"/>
            </a:xfrm>
            <a:prstGeom prst="rect">
              <a:avLst/>
            </a:prstGeom>
          </p:spPr>
        </p:pic>
        <p:pic>
          <p:nvPicPr>
            <p:cNvPr id="41" name="Graphic 40" descr="Checkmark with solid fill">
              <a:extLst>
                <a:ext uri="{FF2B5EF4-FFF2-40B4-BE49-F238E27FC236}">
                  <a16:creationId xmlns:a16="http://schemas.microsoft.com/office/drawing/2014/main" id="{EA18234A-76DD-19BF-80ED-F7BEDF872D3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967843" y="4128758"/>
              <a:ext cx="121990" cy="121990"/>
            </a:xfrm>
            <a:prstGeom prst="rect">
              <a:avLst/>
            </a:prstGeom>
          </p:spPr>
        </p:pic>
        <p:pic>
          <p:nvPicPr>
            <p:cNvPr id="45" name="Graphic 44" descr="Checkmark with solid fill">
              <a:extLst>
                <a:ext uri="{FF2B5EF4-FFF2-40B4-BE49-F238E27FC236}">
                  <a16:creationId xmlns:a16="http://schemas.microsoft.com/office/drawing/2014/main" id="{241F013D-D50E-D174-A280-458B5846F1D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332746" y="3969071"/>
              <a:ext cx="121990" cy="121990"/>
            </a:xfrm>
            <a:prstGeom prst="rect">
              <a:avLst/>
            </a:prstGeom>
          </p:spPr>
        </p:pic>
      </p:grp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042A0ACF-3B10-36AD-1FE9-04EB909F3E41}"/>
              </a:ext>
            </a:extLst>
          </p:cNvPr>
          <p:cNvGrpSpPr/>
          <p:nvPr/>
        </p:nvGrpSpPr>
        <p:grpSpPr>
          <a:xfrm>
            <a:off x="8459259" y="3478822"/>
            <a:ext cx="2713566" cy="1495651"/>
            <a:chOff x="7353473" y="3669661"/>
            <a:chExt cx="2713566" cy="1495651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51E6B5A-7CC0-A2BF-B91E-9B73C1D62576}"/>
                </a:ext>
              </a:extLst>
            </p:cNvPr>
            <p:cNvSpPr txBox="1"/>
            <p:nvPr/>
          </p:nvSpPr>
          <p:spPr>
            <a:xfrm>
              <a:off x="7353473" y="3687984"/>
              <a:ext cx="1468705" cy="1477328"/>
            </a:xfrm>
            <a:prstGeom prst="rect">
              <a:avLst/>
            </a:prstGeom>
            <a:noFill/>
            <a:ln>
              <a:noFill/>
              <a:prstDash val="dash"/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SIM4    </a:t>
              </a:r>
            </a:p>
            <a:p>
              <a:r>
                <a:rPr lang="en-US" sz="1000" dirty="0"/>
                <a:t>SIM5</a:t>
              </a:r>
            </a:p>
            <a:p>
              <a:r>
                <a:rPr lang="en-US" sz="1000" dirty="0"/>
                <a:t>SIM6</a:t>
              </a:r>
            </a:p>
            <a:p>
              <a:r>
                <a:rPr lang="en-US" sz="1000" dirty="0"/>
                <a:t>SIM7</a:t>
              </a:r>
            </a:p>
            <a:p>
              <a:r>
                <a:rPr lang="en-US" sz="1000" dirty="0"/>
                <a:t>SIM8</a:t>
              </a:r>
            </a:p>
            <a:p>
              <a:r>
                <a:rPr lang="en-US" sz="1000" dirty="0"/>
                <a:t>SIM9</a:t>
              </a:r>
            </a:p>
            <a:p>
              <a:r>
                <a:rPr lang="en-US" sz="1000" dirty="0"/>
                <a:t>SIM10</a:t>
              </a:r>
            </a:p>
            <a:p>
              <a:r>
                <a:rPr lang="en-US" sz="1000" dirty="0"/>
                <a:t>SIM11 </a:t>
              </a:r>
            </a:p>
            <a:p>
              <a:endParaRPr lang="en-US" sz="1000" dirty="0"/>
            </a:p>
          </p:txBody>
        </p:sp>
        <p:pic>
          <p:nvPicPr>
            <p:cNvPr id="49" name="Graphic 48" descr="Checkbox Crossed with solid fill">
              <a:extLst>
                <a:ext uri="{FF2B5EF4-FFF2-40B4-BE49-F238E27FC236}">
                  <a16:creationId xmlns:a16="http://schemas.microsoft.com/office/drawing/2014/main" id="{9CCF922C-EDA5-E5FC-C1E6-4182135E9E1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7790461" y="3867179"/>
              <a:ext cx="175357" cy="175357"/>
            </a:xfrm>
            <a:prstGeom prst="rect">
              <a:avLst/>
            </a:prstGeom>
          </p:spPr>
        </p:pic>
        <p:pic>
          <p:nvPicPr>
            <p:cNvPr id="50" name="Graphic 49" descr="Checkbox Crossed with solid fill">
              <a:extLst>
                <a:ext uri="{FF2B5EF4-FFF2-40B4-BE49-F238E27FC236}">
                  <a16:creationId xmlns:a16="http://schemas.microsoft.com/office/drawing/2014/main" id="{865F58CB-655C-3688-7652-B2BB4BA4F8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8092854" y="3870782"/>
              <a:ext cx="175357" cy="175357"/>
            </a:xfrm>
            <a:prstGeom prst="rect">
              <a:avLst/>
            </a:prstGeom>
          </p:spPr>
        </p:pic>
        <p:pic>
          <p:nvPicPr>
            <p:cNvPr id="51" name="Graphic 50" descr="Checkbox Crossed with solid fill">
              <a:extLst>
                <a:ext uri="{FF2B5EF4-FFF2-40B4-BE49-F238E27FC236}">
                  <a16:creationId xmlns:a16="http://schemas.microsoft.com/office/drawing/2014/main" id="{D13B6168-5B37-1540-B978-1A1C073563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7848436" y="4623358"/>
              <a:ext cx="175357" cy="175357"/>
            </a:xfrm>
            <a:prstGeom prst="rect">
              <a:avLst/>
            </a:prstGeom>
          </p:spPr>
        </p:pic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087B92F6-0AAF-2303-4A40-7B56DDD42682}"/>
                </a:ext>
              </a:extLst>
            </p:cNvPr>
            <p:cNvCxnSpPr>
              <a:cxnSpLocks/>
            </p:cNvCxnSpPr>
            <p:nvPr/>
          </p:nvCxnSpPr>
          <p:spPr>
            <a:xfrm>
              <a:off x="7937057" y="3951327"/>
              <a:ext cx="179286" cy="0"/>
            </a:xfrm>
            <a:prstGeom prst="straightConnector1">
              <a:avLst/>
            </a:prstGeom>
            <a:ln>
              <a:noFill/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81572C07-0ED1-BB7B-84FB-10700AC8B718}"/>
                </a:ext>
              </a:extLst>
            </p:cNvPr>
            <p:cNvCxnSpPr>
              <a:cxnSpLocks/>
            </p:cNvCxnSpPr>
            <p:nvPr/>
          </p:nvCxnSpPr>
          <p:spPr>
            <a:xfrm>
              <a:off x="8001246" y="4711036"/>
              <a:ext cx="179286" cy="0"/>
            </a:xfrm>
            <a:prstGeom prst="straightConnector1">
              <a:avLst/>
            </a:prstGeom>
            <a:ln>
              <a:noFill/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63" name="Graphic 62" descr="Checkmark with solid fill">
              <a:extLst>
                <a:ext uri="{FF2B5EF4-FFF2-40B4-BE49-F238E27FC236}">
                  <a16:creationId xmlns:a16="http://schemas.microsoft.com/office/drawing/2014/main" id="{623192CB-F2CB-5D1D-FD71-1B9E1DF64E7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7823562" y="3736404"/>
              <a:ext cx="121990" cy="121990"/>
            </a:xfrm>
            <a:prstGeom prst="rect">
              <a:avLst/>
            </a:prstGeom>
          </p:spPr>
        </p:pic>
        <p:pic>
          <p:nvPicPr>
            <p:cNvPr id="64" name="Graphic 63" descr="Checkmark with solid fill">
              <a:extLst>
                <a:ext uri="{FF2B5EF4-FFF2-40B4-BE49-F238E27FC236}">
                  <a16:creationId xmlns:a16="http://schemas.microsoft.com/office/drawing/2014/main" id="{64A2592F-29E3-6374-EDDC-2FC6462ED8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8433162" y="3890332"/>
              <a:ext cx="121990" cy="121990"/>
            </a:xfrm>
            <a:prstGeom prst="rect">
              <a:avLst/>
            </a:prstGeom>
          </p:spPr>
        </p:pic>
        <p:pic>
          <p:nvPicPr>
            <p:cNvPr id="65" name="Graphic 64" descr="Checkmark with solid fill">
              <a:extLst>
                <a:ext uri="{FF2B5EF4-FFF2-40B4-BE49-F238E27FC236}">
                  <a16:creationId xmlns:a16="http://schemas.microsoft.com/office/drawing/2014/main" id="{5357D005-B594-342E-24C9-28206D2DF3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7805913" y="4050357"/>
              <a:ext cx="121990" cy="121990"/>
            </a:xfrm>
            <a:prstGeom prst="rect">
              <a:avLst/>
            </a:prstGeom>
          </p:spPr>
        </p:pic>
        <p:pic>
          <p:nvPicPr>
            <p:cNvPr id="66" name="Graphic 65" descr="Checkmark with solid fill">
              <a:extLst>
                <a:ext uri="{FF2B5EF4-FFF2-40B4-BE49-F238E27FC236}">
                  <a16:creationId xmlns:a16="http://schemas.microsoft.com/office/drawing/2014/main" id="{556892B5-BFFB-5C96-85CF-D3A4F62A7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7805913" y="4209391"/>
              <a:ext cx="121990" cy="121990"/>
            </a:xfrm>
            <a:prstGeom prst="rect">
              <a:avLst/>
            </a:prstGeom>
          </p:spPr>
        </p:pic>
        <p:pic>
          <p:nvPicPr>
            <p:cNvPr id="67" name="Graphic 66" descr="Checkmark with solid fill">
              <a:extLst>
                <a:ext uri="{FF2B5EF4-FFF2-40B4-BE49-F238E27FC236}">
                  <a16:creationId xmlns:a16="http://schemas.microsoft.com/office/drawing/2014/main" id="{C90CFFB0-C77C-6196-2FFE-3537D766A7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7810021" y="4369384"/>
              <a:ext cx="121990" cy="121990"/>
            </a:xfrm>
            <a:prstGeom prst="rect">
              <a:avLst/>
            </a:prstGeom>
          </p:spPr>
        </p:pic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2BB608B7-3568-D45F-FCD9-A31CD3B0E6B4}"/>
                </a:ext>
              </a:extLst>
            </p:cNvPr>
            <p:cNvCxnSpPr>
              <a:cxnSpLocks/>
            </p:cNvCxnSpPr>
            <p:nvPr/>
          </p:nvCxnSpPr>
          <p:spPr>
            <a:xfrm>
              <a:off x="8247031" y="3952671"/>
              <a:ext cx="179286" cy="0"/>
            </a:xfrm>
            <a:prstGeom prst="straightConnector1">
              <a:avLst/>
            </a:prstGeom>
            <a:ln>
              <a:noFill/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69" name="Graphic 68" descr="Checkmark with solid fill">
              <a:extLst>
                <a:ext uri="{FF2B5EF4-FFF2-40B4-BE49-F238E27FC236}">
                  <a16:creationId xmlns:a16="http://schemas.microsoft.com/office/drawing/2014/main" id="{3F4EF3A5-3972-0521-5F81-04B03AE9CF0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7808295" y="4505092"/>
              <a:ext cx="121990" cy="121990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45AE2BE-0014-CA39-E1E8-9A737F5BB822}"/>
                </a:ext>
              </a:extLst>
            </p:cNvPr>
            <p:cNvSpPr txBox="1"/>
            <p:nvPr/>
          </p:nvSpPr>
          <p:spPr>
            <a:xfrm>
              <a:off x="8738644" y="3669661"/>
              <a:ext cx="1328395" cy="1323439"/>
            </a:xfrm>
            <a:prstGeom prst="rect">
              <a:avLst/>
            </a:prstGeom>
            <a:noFill/>
            <a:ln>
              <a:noFill/>
              <a:prstDash val="dash"/>
            </a:ln>
          </p:spPr>
          <p:txBody>
            <a:bodyPr wrap="square">
              <a:spAutoFit/>
            </a:bodyPr>
            <a:lstStyle/>
            <a:p>
              <a:r>
                <a:rPr lang="en-US" sz="1000" dirty="0"/>
                <a:t>SIM12</a:t>
              </a:r>
            </a:p>
            <a:p>
              <a:r>
                <a:rPr lang="en-US" sz="1000" dirty="0"/>
                <a:t>SIM13</a:t>
              </a:r>
            </a:p>
            <a:p>
              <a:r>
                <a:rPr lang="en-US" sz="1000" dirty="0"/>
                <a:t>SIM14</a:t>
              </a:r>
            </a:p>
            <a:p>
              <a:r>
                <a:rPr lang="en-US" sz="1000" dirty="0"/>
                <a:t>SIM15</a:t>
              </a:r>
            </a:p>
            <a:p>
              <a:r>
                <a:rPr lang="en-US" sz="1000" dirty="0"/>
                <a:t>SIM16</a:t>
              </a:r>
            </a:p>
            <a:p>
              <a:r>
                <a:rPr lang="en-US" sz="1000" dirty="0"/>
                <a:t>SIM17  withdrew</a:t>
              </a:r>
            </a:p>
            <a:p>
              <a:r>
                <a:rPr lang="en-US" sz="1000" dirty="0"/>
                <a:t>SIM18</a:t>
              </a:r>
            </a:p>
            <a:p>
              <a:r>
                <a:rPr lang="en-US" sz="1000" dirty="0"/>
                <a:t>SIM19</a:t>
              </a:r>
            </a:p>
          </p:txBody>
        </p:sp>
        <p:pic>
          <p:nvPicPr>
            <p:cNvPr id="52" name="Graphic 51" descr="Checkbox Crossed with solid fill">
              <a:extLst>
                <a:ext uri="{FF2B5EF4-FFF2-40B4-BE49-F238E27FC236}">
                  <a16:creationId xmlns:a16="http://schemas.microsoft.com/office/drawing/2014/main" id="{D562F448-78C4-5818-0CE3-7E20BC3B65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9233549" y="3700329"/>
              <a:ext cx="175357" cy="175357"/>
            </a:xfrm>
            <a:prstGeom prst="rect">
              <a:avLst/>
            </a:prstGeom>
          </p:spPr>
        </p:pic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8D464133-442E-722E-24EF-06F34D4800E3}"/>
                </a:ext>
              </a:extLst>
            </p:cNvPr>
            <p:cNvCxnSpPr>
              <a:cxnSpLocks/>
            </p:cNvCxnSpPr>
            <p:nvPr/>
          </p:nvCxnSpPr>
          <p:spPr>
            <a:xfrm>
              <a:off x="9380123" y="3788007"/>
              <a:ext cx="179286" cy="0"/>
            </a:xfrm>
            <a:prstGeom prst="straightConnector1">
              <a:avLst/>
            </a:prstGeom>
            <a:ln>
              <a:noFill/>
              <a:prstDash val="dash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70" name="Graphic 69" descr="Checkmark with solid fill">
              <a:extLst>
                <a:ext uri="{FF2B5EF4-FFF2-40B4-BE49-F238E27FC236}">
                  <a16:creationId xmlns:a16="http://schemas.microsoft.com/office/drawing/2014/main" id="{B43C2693-E940-5403-07A2-BF399E33E2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9583993" y="3727012"/>
              <a:ext cx="121990" cy="121990"/>
            </a:xfrm>
            <a:prstGeom prst="rect">
              <a:avLst/>
            </a:prstGeom>
          </p:spPr>
        </p:pic>
        <p:pic>
          <p:nvPicPr>
            <p:cNvPr id="71" name="Graphic 70" descr="Checkmark with solid fill">
              <a:extLst>
                <a:ext uri="{FF2B5EF4-FFF2-40B4-BE49-F238E27FC236}">
                  <a16:creationId xmlns:a16="http://schemas.microsoft.com/office/drawing/2014/main" id="{7EAB4CFB-08A2-814A-B316-A92262E6F3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9260232" y="3896086"/>
              <a:ext cx="121990" cy="121990"/>
            </a:xfrm>
            <a:prstGeom prst="rect">
              <a:avLst/>
            </a:prstGeom>
          </p:spPr>
        </p:pic>
        <p:pic>
          <p:nvPicPr>
            <p:cNvPr id="73" name="Graphic 72" descr="Checkmark with solid fill">
              <a:extLst>
                <a:ext uri="{FF2B5EF4-FFF2-40B4-BE49-F238E27FC236}">
                  <a16:creationId xmlns:a16="http://schemas.microsoft.com/office/drawing/2014/main" id="{0CD23030-15C9-17C0-A2F2-D24ED6265C5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9270157" y="4618799"/>
              <a:ext cx="121990" cy="121990"/>
            </a:xfrm>
            <a:prstGeom prst="rect">
              <a:avLst/>
            </a:prstGeom>
          </p:spPr>
        </p:pic>
        <p:pic>
          <p:nvPicPr>
            <p:cNvPr id="74" name="Graphic 73" descr="Checkmark with solid fill">
              <a:extLst>
                <a:ext uri="{FF2B5EF4-FFF2-40B4-BE49-F238E27FC236}">
                  <a16:creationId xmlns:a16="http://schemas.microsoft.com/office/drawing/2014/main" id="{74969A76-3977-B609-CBF1-E8549EE0E3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9260232" y="4342331"/>
              <a:ext cx="121990" cy="121990"/>
            </a:xfrm>
            <a:prstGeom prst="rect">
              <a:avLst/>
            </a:prstGeom>
          </p:spPr>
        </p:pic>
        <p:pic>
          <p:nvPicPr>
            <p:cNvPr id="75" name="Graphic 74" descr="Checkmark with solid fill">
              <a:extLst>
                <a:ext uri="{FF2B5EF4-FFF2-40B4-BE49-F238E27FC236}">
                  <a16:creationId xmlns:a16="http://schemas.microsoft.com/office/drawing/2014/main" id="{4B2301E7-7DF4-D8FD-CBAB-A01D67AF80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9272327" y="4210437"/>
              <a:ext cx="121990" cy="121990"/>
            </a:xfrm>
            <a:prstGeom prst="rect">
              <a:avLst/>
            </a:prstGeom>
          </p:spPr>
        </p:pic>
        <p:grpSp>
          <p:nvGrpSpPr>
            <p:cNvPr id="114" name="Group 113">
              <a:extLst>
                <a:ext uri="{FF2B5EF4-FFF2-40B4-BE49-F238E27FC236}">
                  <a16:creationId xmlns:a16="http://schemas.microsoft.com/office/drawing/2014/main" id="{4DA951CD-BF3E-1B61-4246-8780CC9996C5}"/>
                </a:ext>
              </a:extLst>
            </p:cNvPr>
            <p:cNvGrpSpPr/>
            <p:nvPr/>
          </p:nvGrpSpPr>
          <p:grpSpPr>
            <a:xfrm>
              <a:off x="9226414" y="4011291"/>
              <a:ext cx="697972" cy="175357"/>
              <a:chOff x="9361786" y="3991534"/>
              <a:chExt cx="697972" cy="175357"/>
            </a:xfrm>
          </p:grpSpPr>
          <p:pic>
            <p:nvPicPr>
              <p:cNvPr id="47" name="Graphic 46" descr="Checkbox Crossed with solid fill">
                <a:extLst>
                  <a:ext uri="{FF2B5EF4-FFF2-40B4-BE49-F238E27FC236}">
                    <a16:creationId xmlns:a16="http://schemas.microsoft.com/office/drawing/2014/main" id="{70AC1349-FFE6-61FA-E77E-6DC50D23E3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9361786" y="3991534"/>
                <a:ext cx="175357" cy="175357"/>
              </a:xfrm>
              <a:prstGeom prst="rect">
                <a:avLst/>
              </a:prstGeom>
            </p:spPr>
          </p:pic>
          <p:pic>
            <p:nvPicPr>
              <p:cNvPr id="60" name="Graphic 59" descr="Checkbox Crossed with solid fill">
                <a:extLst>
                  <a:ext uri="{FF2B5EF4-FFF2-40B4-BE49-F238E27FC236}">
                    <a16:creationId xmlns:a16="http://schemas.microsoft.com/office/drawing/2014/main" id="{07A31904-7BD4-DE90-E1CE-E0CFBAE44D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9535991" y="3991534"/>
                <a:ext cx="175357" cy="175357"/>
              </a:xfrm>
              <a:prstGeom prst="rect">
                <a:avLst/>
              </a:prstGeom>
            </p:spPr>
          </p:pic>
          <p:pic>
            <p:nvPicPr>
              <p:cNvPr id="61" name="Graphic 60" descr="Checkbox Crossed with solid fill">
                <a:extLst>
                  <a:ext uri="{FF2B5EF4-FFF2-40B4-BE49-F238E27FC236}">
                    <a16:creationId xmlns:a16="http://schemas.microsoft.com/office/drawing/2014/main" id="{CBEA792D-B6BB-2D71-03AA-56E6E8556A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9710196" y="3991534"/>
                <a:ext cx="175357" cy="175357"/>
              </a:xfrm>
              <a:prstGeom prst="rect">
                <a:avLst/>
              </a:prstGeom>
            </p:spPr>
          </p:pic>
          <p:pic>
            <p:nvPicPr>
              <p:cNvPr id="82" name="Graphic 81" descr="Checkbox Crossed with solid fill">
                <a:extLst>
                  <a:ext uri="{FF2B5EF4-FFF2-40B4-BE49-F238E27FC236}">
                    <a16:creationId xmlns:a16="http://schemas.microsoft.com/office/drawing/2014/main" id="{102DE1CF-C13C-92CE-FD57-0A0D551E75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9884401" y="3991534"/>
                <a:ext cx="175357" cy="175357"/>
              </a:xfrm>
              <a:prstGeom prst="rect">
                <a:avLst/>
              </a:prstGeom>
            </p:spPr>
          </p:pic>
        </p:grpSp>
        <p:pic>
          <p:nvPicPr>
            <p:cNvPr id="115" name="Graphic 114" descr="Checkmark with solid fill">
              <a:extLst>
                <a:ext uri="{FF2B5EF4-FFF2-40B4-BE49-F238E27FC236}">
                  <a16:creationId xmlns:a16="http://schemas.microsoft.com/office/drawing/2014/main" id="{CD4699A8-2F2B-4DD5-C01A-5A2D8C5AB1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8211284" y="4650041"/>
              <a:ext cx="121990" cy="121990"/>
            </a:xfrm>
            <a:prstGeom prst="rect">
              <a:avLst/>
            </a:prstGeom>
          </p:spPr>
        </p:pic>
      </p:grpSp>
      <p:pic>
        <p:nvPicPr>
          <p:cNvPr id="2" name="Graphic 1" descr="Checkmark with solid fill">
            <a:extLst>
              <a:ext uri="{FF2B5EF4-FFF2-40B4-BE49-F238E27FC236}">
                <a16:creationId xmlns:a16="http://schemas.microsoft.com/office/drawing/2014/main" id="{9F40F251-3113-D478-622D-A0C50953E4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384415" y="4607876"/>
            <a:ext cx="121990" cy="121990"/>
          </a:xfrm>
          <a:prstGeom prst="rect">
            <a:avLst/>
          </a:prstGeom>
        </p:spPr>
      </p:pic>
      <p:pic>
        <p:nvPicPr>
          <p:cNvPr id="4" name="Graphic 3" descr="Checkmark with solid fill">
            <a:extLst>
              <a:ext uri="{FF2B5EF4-FFF2-40B4-BE49-F238E27FC236}">
                <a16:creationId xmlns:a16="http://schemas.microsoft.com/office/drawing/2014/main" id="{D9FD56AB-8806-E63B-EB7C-1175AE277A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8914081" y="4609528"/>
            <a:ext cx="121990" cy="121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1865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8C74060-996F-C9F2-882D-87233E9276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4190696"/>
              </p:ext>
            </p:extLst>
          </p:nvPr>
        </p:nvGraphicFramePr>
        <p:xfrm>
          <a:off x="885825" y="643466"/>
          <a:ext cx="10401299" cy="59305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786">
                  <a:extLst>
                    <a:ext uri="{9D8B030D-6E8A-4147-A177-3AD203B41FA5}">
                      <a16:colId xmlns:a16="http://schemas.microsoft.com/office/drawing/2014/main" val="3271358513"/>
                    </a:ext>
                  </a:extLst>
                </a:gridCol>
                <a:gridCol w="2898224">
                  <a:extLst>
                    <a:ext uri="{9D8B030D-6E8A-4147-A177-3AD203B41FA5}">
                      <a16:colId xmlns:a16="http://schemas.microsoft.com/office/drawing/2014/main" val="1863547888"/>
                    </a:ext>
                  </a:extLst>
                </a:gridCol>
                <a:gridCol w="1825390">
                  <a:extLst>
                    <a:ext uri="{9D8B030D-6E8A-4147-A177-3AD203B41FA5}">
                      <a16:colId xmlns:a16="http://schemas.microsoft.com/office/drawing/2014/main" val="737028864"/>
                    </a:ext>
                  </a:extLst>
                </a:gridCol>
                <a:gridCol w="4152899">
                  <a:extLst>
                    <a:ext uri="{9D8B030D-6E8A-4147-A177-3AD203B41FA5}">
                      <a16:colId xmlns:a16="http://schemas.microsoft.com/office/drawing/2014/main" val="1947804188"/>
                    </a:ext>
                  </a:extLst>
                </a:gridCol>
              </a:tblGrid>
              <a:tr h="242221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ssion_id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raw_wear_time_hours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wear_time_days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AU" sz="1300" u="none" strike="noStrike" dirty="0" err="1">
                          <a:effectLst/>
                        </a:rPr>
                        <a:t>failure_reason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011739572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4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41:26:4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1.726851852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xternal wire breakage</a:t>
                      </a: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922648794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5-1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874125056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5-2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1165905308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5-3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45:48:18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1.908541667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The device completed the study without incident. The shorter duration is explained by the two </a:t>
                      </a:r>
                      <a:r>
                        <a:rPr lang="en-AU" sz="13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eceding failed </a:t>
                      </a:r>
                      <a:r>
                        <a:rPr lang="en-AU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evices consumed part of the study time allotted to the study</a:t>
                      </a: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061814763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6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2:12:41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3.00880787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1183236090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7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1:25:43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7619213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4016484859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8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1:33:02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81273148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82650119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09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1:30:21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79409722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1001473279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0-1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0:00:00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392375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0-2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1:10:29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65613426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1935724334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1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0:48:44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50509259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802531889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2-1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0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1776868035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2-2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68:57:55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873553241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48947571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3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1:41:29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87141204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344940395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4-1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468719601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4-2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741489860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4-3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:00:0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634097466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4-4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0:00:00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0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ensor not responding to glucose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362811160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5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0:34:25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4056713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924972562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6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0:56:21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55798611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923347003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8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0:26:59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35405093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3080512154"/>
                  </a:ext>
                </a:extLst>
              </a:tr>
              <a:tr h="2422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>
                          <a:effectLst/>
                        </a:rPr>
                        <a:t>SM19</a:t>
                      </a:r>
                      <a:endParaRPr lang="en-AU" sz="13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70:16:04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AU" sz="1300" u="none" strike="noStrike" dirty="0">
                          <a:effectLst/>
                        </a:rPr>
                        <a:t>2.927824074</a:t>
                      </a: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AU" sz="13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305" marR="7305" marT="7305" marB="0" anchor="b"/>
                </a:tc>
                <a:extLst>
                  <a:ext uri="{0D108BD9-81ED-4DB2-BD59-A6C34878D82A}">
                    <a16:rowId xmlns:a16="http://schemas.microsoft.com/office/drawing/2014/main" val="2974869407"/>
                  </a:ext>
                </a:extLst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5BF78B8E-D48A-7EC6-EC44-969DF8803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2114" y="91035"/>
            <a:ext cx="4345612" cy="651405"/>
          </a:xfrm>
        </p:spPr>
        <p:txBody>
          <a:bodyPr>
            <a:normAutofit/>
          </a:bodyPr>
          <a:lstStyle/>
          <a:p>
            <a:pPr algn="ctr"/>
            <a:r>
              <a:rPr lang="en-US" sz="1800" b="1" dirty="0">
                <a:latin typeface="+mn-lt"/>
              </a:rPr>
              <a:t>S2 Device Survival</a:t>
            </a:r>
          </a:p>
        </p:txBody>
      </p:sp>
    </p:spTree>
    <p:extLst>
      <p:ext uri="{BB962C8B-B14F-4D97-AF65-F5344CB8AC3E}">
        <p14:creationId xmlns:p14="http://schemas.microsoft.com/office/powerpoint/2010/main" val="800411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BF7B79-0160-2102-EFDF-F4F8CDE83C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6790622-ECD6-B1EE-2717-56A6434863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2466875"/>
              </p:ext>
            </p:extLst>
          </p:nvPr>
        </p:nvGraphicFramePr>
        <p:xfrm>
          <a:off x="1539240" y="1664969"/>
          <a:ext cx="3862818" cy="29555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13269">
                  <a:extLst>
                    <a:ext uri="{9D8B030D-6E8A-4147-A177-3AD203B41FA5}">
                      <a16:colId xmlns:a16="http://schemas.microsoft.com/office/drawing/2014/main" val="3805627513"/>
                    </a:ext>
                  </a:extLst>
                </a:gridCol>
                <a:gridCol w="1216033">
                  <a:extLst>
                    <a:ext uri="{9D8B030D-6E8A-4147-A177-3AD203B41FA5}">
                      <a16:colId xmlns:a16="http://schemas.microsoft.com/office/drawing/2014/main" val="3977659158"/>
                    </a:ext>
                  </a:extLst>
                </a:gridCol>
                <a:gridCol w="1133516">
                  <a:extLst>
                    <a:ext uri="{9D8B030D-6E8A-4147-A177-3AD203B41FA5}">
                      <a16:colId xmlns:a16="http://schemas.microsoft.com/office/drawing/2014/main" val="2687975743"/>
                    </a:ext>
                  </a:extLst>
                </a:gridCol>
              </a:tblGrid>
              <a:tr h="455686"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eference to YSI, no cutoff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5276127"/>
                  </a:ext>
                </a:extLst>
              </a:tr>
              <a:tr h="4999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ime range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_PDT (%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 err="1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_YSI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407353042"/>
                  </a:ext>
                </a:extLst>
              </a:tr>
              <a:tr h="4999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st </a:t>
                      </a:r>
                      <a:r>
                        <a:rPr lang="en-US" sz="1400" b="1" kern="100" dirty="0" err="1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Excur</a:t>
                      </a: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 (0-6h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2.7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25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3221887633"/>
                  </a:ext>
                </a:extLst>
              </a:tr>
              <a:tr h="4999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nd excur (44-53h)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0.3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269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838989598"/>
                  </a:ext>
                </a:extLst>
              </a:tr>
              <a:tr h="4999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1.6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594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608859430"/>
                  </a:ext>
                </a:extLst>
              </a:tr>
              <a:tr h="4999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SD (%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0.2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4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798045879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A1A73FF-12C2-1B8F-4AD5-741EF2774F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688953"/>
              </p:ext>
            </p:extLst>
          </p:nvPr>
        </p:nvGraphicFramePr>
        <p:xfrm>
          <a:off x="5610946" y="1664969"/>
          <a:ext cx="3807211" cy="39096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231493">
                  <a:extLst>
                    <a:ext uri="{9D8B030D-6E8A-4147-A177-3AD203B41FA5}">
                      <a16:colId xmlns:a16="http://schemas.microsoft.com/office/drawing/2014/main" val="2506338387"/>
                    </a:ext>
                  </a:extLst>
                </a:gridCol>
                <a:gridCol w="1333089">
                  <a:extLst>
                    <a:ext uri="{9D8B030D-6E8A-4147-A177-3AD203B41FA5}">
                      <a16:colId xmlns:a16="http://schemas.microsoft.com/office/drawing/2014/main" val="3489825714"/>
                    </a:ext>
                  </a:extLst>
                </a:gridCol>
                <a:gridCol w="1242629">
                  <a:extLst>
                    <a:ext uri="{9D8B030D-6E8A-4147-A177-3AD203B41FA5}">
                      <a16:colId xmlns:a16="http://schemas.microsoft.com/office/drawing/2014/main" val="3106966168"/>
                    </a:ext>
                  </a:extLst>
                </a:gridCol>
              </a:tblGrid>
              <a:tr h="460045"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Reference to BG, no cutoff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5606191"/>
                  </a:ext>
                </a:extLst>
              </a:tr>
              <a:tr h="5008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ime range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G_PDT (%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 err="1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n_BG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3171424979"/>
                  </a:ext>
                </a:extLst>
              </a:tr>
              <a:tr h="49583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ay1 (0-17h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3.1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490</a:t>
                      </a:r>
                      <a:endParaRPr lang="en-US" sz="1400" kern="10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3700976310"/>
                  </a:ext>
                </a:extLst>
              </a:tr>
              <a:tr h="50169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ay2 (17-41h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3.5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81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168250754"/>
                  </a:ext>
                </a:extLst>
              </a:tr>
              <a:tr h="49583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ay3 (41-65h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0.2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392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1377947025"/>
                  </a:ext>
                </a:extLst>
              </a:tr>
              <a:tr h="49583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Day4 (&gt; 65h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8.7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3331221566"/>
                  </a:ext>
                </a:extLst>
              </a:tr>
              <a:tr h="47007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2.0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082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43231568"/>
                  </a:ext>
                </a:extLst>
              </a:tr>
              <a:tr h="4895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b="1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SD (%)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400" kern="100" dirty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1.1</a:t>
                      </a:r>
                      <a:endParaRPr lang="en-US" sz="1400" kern="100" dirty="0">
                        <a:effectLst/>
                        <a:latin typeface="Aptos" panose="020B0004020202020204" pitchFamily="34" charset="0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buNone/>
                      </a:pPr>
                      <a:endParaRPr lang="en-US" sz="14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1623323450"/>
                  </a:ext>
                </a:extLst>
              </a:tr>
            </a:tbl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F71880C4-F1E3-E838-CD81-DD3CA0F7AF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9839" y="643485"/>
            <a:ext cx="4345612" cy="651405"/>
          </a:xfrm>
        </p:spPr>
        <p:txBody>
          <a:bodyPr>
            <a:normAutofit/>
          </a:bodyPr>
          <a:lstStyle/>
          <a:p>
            <a:pPr algn="ctr"/>
            <a:r>
              <a:rPr lang="en-US" sz="1800" b="1" dirty="0">
                <a:latin typeface="+mn-lt"/>
              </a:rPr>
              <a:t>S3 MARD –Day by day summary</a:t>
            </a:r>
          </a:p>
        </p:txBody>
      </p:sp>
    </p:spTree>
    <p:extLst>
      <p:ext uri="{BB962C8B-B14F-4D97-AF65-F5344CB8AC3E}">
        <p14:creationId xmlns:p14="http://schemas.microsoft.com/office/powerpoint/2010/main" val="458494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321</Words>
  <Application>Microsoft Office PowerPoint</Application>
  <PresentationFormat>Widescreen</PresentationFormat>
  <Paragraphs>15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ptos Narrow</vt:lpstr>
      <vt:lpstr>Arial</vt:lpstr>
      <vt:lpstr>Calibri</vt:lpstr>
      <vt:lpstr>Office Theme</vt:lpstr>
      <vt:lpstr>Supplementary Appendix</vt:lpstr>
      <vt:lpstr>Index</vt:lpstr>
      <vt:lpstr>S1 Device Failures</vt:lpstr>
      <vt:lpstr>S2 Device Survival</vt:lpstr>
      <vt:lpstr>S3 MARD –Day by day summar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nnah Cunningham</dc:creator>
  <cp:lastModifiedBy>David O'Neal</cp:lastModifiedBy>
  <cp:revision>6</cp:revision>
  <dcterms:created xsi:type="dcterms:W3CDTF">2026-01-04T22:47:13Z</dcterms:created>
  <dcterms:modified xsi:type="dcterms:W3CDTF">2026-02-28T21:12:46Z</dcterms:modified>
</cp:coreProperties>
</file>